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387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992961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321548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57649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10328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00447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75680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59931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182474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11083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791955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51726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1245B0-603A-450E-BCB2-99628013ADDF}" type="datetimeFigureOut">
              <a:rPr lang="th-TH" smtClean="0"/>
              <a:t>12/11/5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1A33B1-886A-4179-A5D6-FB917E5A927D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213908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ontent Placeholder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6141113"/>
              </p:ext>
            </p:extLst>
          </p:nvPr>
        </p:nvGraphicFramePr>
        <p:xfrm>
          <a:off x="242764" y="1556792"/>
          <a:ext cx="8721724" cy="398951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89100"/>
                <a:gridCol w="2344208"/>
                <a:gridCol w="2344208"/>
                <a:gridCol w="2344208"/>
              </a:tblGrid>
              <a:tr h="504056">
                <a:tc>
                  <a:txBody>
                    <a:bodyPr/>
                    <a:lstStyle/>
                    <a:p>
                      <a:r>
                        <a:rPr lang="en-US" sz="18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in</a:t>
                      </a:r>
                      <a:endParaRPr 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-intensity</a:t>
                      </a:r>
                      <a: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b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 LDL-C by ≥50%</a:t>
                      </a:r>
                      <a:endParaRPr lang="en-US" sz="18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-intensity </a:t>
                      </a:r>
                    </a:p>
                    <a:p>
                      <a: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 LDL-C by </a:t>
                      </a:r>
                      <a:r>
                        <a:rPr lang="en-GB" sz="1800" baseline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– &lt;50</a:t>
                      </a:r>
                      <a: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US" sz="1800" i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-intensity </a:t>
                      </a:r>
                      <a:b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↓ LDL-C by &lt;30%*</a:t>
                      </a:r>
                      <a:endParaRPr lang="en-US" sz="1800" i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/>
                </a:tc>
              </a:tr>
              <a:tr h="360040"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orvastatin</a:t>
                      </a:r>
                      <a:endParaRPr 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–80 mg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–20</a:t>
                      </a:r>
                      <a: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g</a:t>
                      </a:r>
                      <a:endParaRPr lang="en-US" sz="18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360040">
                <a:tc>
                  <a:txBody>
                    <a:bodyPr/>
                    <a:lstStyle/>
                    <a:p>
                      <a:r>
                        <a:rPr lang="en-GB" sz="18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suvastatin</a:t>
                      </a:r>
                      <a:endParaRPr 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–40 mg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u="none" strike="noStrike" kern="12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800" u="none" strike="noStrike" kern="12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g </a:t>
                      </a:r>
                      <a:endParaRPr lang="en-US" sz="1800" b="0" i="0" u="none" strike="noStrike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457670"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mvastatin</a:t>
                      </a:r>
                      <a:endParaRPr 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u="none" strike="noStrike" kern="12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–40 mg</a:t>
                      </a:r>
                      <a:endParaRPr lang="en-US" sz="1800" b="0" i="0" u="none" strike="noStrike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u="none" strike="noStrike" kern="12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g</a:t>
                      </a:r>
                      <a:endParaRPr lang="en-US" sz="1800" b="0" i="1" u="none" strike="noStrike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385662"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avastatin</a:t>
                      </a:r>
                      <a:endParaRPr 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–80 mg</a:t>
                      </a:r>
                      <a:endParaRPr lang="en-US" sz="18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u="none" strike="noStrike" kern="12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20 mg</a:t>
                      </a:r>
                      <a:endParaRPr lang="en-US" sz="18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504056">
                <a:tc>
                  <a:txBody>
                    <a:bodyPr/>
                    <a:lstStyle/>
                    <a:p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vastatin</a:t>
                      </a:r>
                      <a:endParaRPr 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mg</a:t>
                      </a:r>
                      <a:endParaRPr lang="en-US" sz="18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u="none" strike="noStrike" kern="12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mg</a:t>
                      </a:r>
                      <a:endParaRPr lang="en-US" sz="18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457670">
                <a:tc>
                  <a:txBody>
                    <a:bodyPr/>
                    <a:lstStyle/>
                    <a:p>
                      <a:r>
                        <a:rPr lang="en-GB" sz="18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vastatin</a:t>
                      </a:r>
                      <a: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XL</a:t>
                      </a:r>
                      <a:endParaRPr lang="en-US" sz="18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 mg</a:t>
                      </a:r>
                      <a:endParaRPr lang="en-US" sz="1800" b="0" i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427190">
                <a:tc>
                  <a:txBody>
                    <a:bodyPr/>
                    <a:lstStyle/>
                    <a:p>
                      <a:r>
                        <a:rPr lang="en-GB" sz="18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vastatin</a:t>
                      </a:r>
                      <a:endParaRPr 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mg bid</a:t>
                      </a:r>
                      <a:endParaRPr lang="en-US" sz="1800" b="1" i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r>
                        <a:rPr lang="en-US" sz="1800" u="none" strike="noStrike" kern="12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40 mg</a:t>
                      </a:r>
                      <a:endParaRPr lang="en-US" sz="1800" b="0" i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385662">
                <a:tc>
                  <a:txBody>
                    <a:bodyPr/>
                    <a:lstStyle/>
                    <a:p>
                      <a:r>
                        <a:rPr lang="en-GB" sz="18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tvastatin</a:t>
                      </a:r>
                      <a:endParaRPr lang="en-US" sz="18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–4 mg</a:t>
                      </a:r>
                      <a:endParaRPr lang="en-US" sz="1800" b="0" i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g</a:t>
                      </a:r>
                      <a:endParaRPr lang="en-US" sz="1800" b="0" i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468418" y="262243"/>
            <a:ext cx="24240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1</a:t>
            </a:r>
            <a:endParaRPr lang="th-TH" sz="20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3317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7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shiba</dc:creator>
  <cp:lastModifiedBy>Nuntakorn Thongtang</cp:lastModifiedBy>
  <cp:revision>3</cp:revision>
  <dcterms:created xsi:type="dcterms:W3CDTF">2016-10-12T13:46:25Z</dcterms:created>
  <dcterms:modified xsi:type="dcterms:W3CDTF">2016-11-12T01:10:11Z</dcterms:modified>
</cp:coreProperties>
</file>